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68" r:id="rId3"/>
    <p:sldId id="260" r:id="rId4"/>
    <p:sldId id="26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08EE09F-EA94-4334-90A2-8449FA565CAC}" v="1" dt="2026-04-11T19:02:21.7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30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5BA080-D62C-4B70-8F32-BC51F7B9CFCB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3745F-6A85-4706-AAA5-B3ACA00D96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90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211885-66A9-42D5-993F-64AA5E88DB0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838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1AC9DB-B813-5812-D248-5914D4D95E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201C7B-921E-1D54-E58B-9ECA3DE06F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681752-DE11-2755-FE78-7F5A554D8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FBC3B-2757-5426-6432-1130F278E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5415FB-6B8E-4281-F60C-BD9FFAB31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483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E27DE-3D60-DDE1-7A7E-B984E5D62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2970D-6045-B69B-B1A1-22080475CA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ACB15-C974-1F53-8948-516EFC957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FFA924-F6CA-AB50-8E2C-1D330902E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58C84-1F03-0760-9D12-1C4FCD2A1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081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6CC236-8A07-7F3C-2697-EB81D3EC62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C80D97-AD99-9BF2-5952-43AB1F118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1925FE-1293-0720-F0AE-F247404C0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D91B7A-B011-3FAD-D1D4-5BA338D68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E32CB4-4D80-1551-4676-696D2D26B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161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AD871-634D-01E9-C2BC-0633694A1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57E2CB-9DCD-D6C9-56EC-A7DA623344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E6ABF9-422C-1D19-42E3-CE8E877D7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948287-2B29-9491-FFBB-6E8D1F937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592687-E2E2-42A1-09E1-962F294A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96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623B0-7FAD-12E3-471C-9A714F30B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C53E07-4A11-3CE8-C07B-458139A5A0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0338D4-4AA9-DDAE-0B96-D0B12DF4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472CB7-7510-EBB9-CB8D-0F72A89FE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D00C31-02EC-8C4E-058E-264B6971A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363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69096-D6FB-6B5E-908D-8A20FE23FB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349023-B087-6FC6-32C7-4144E74CF9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22BFC3-ABC7-422E-2F82-918C8800FB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FADC3D-21E9-2DBC-DDC1-EBB6B30A7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64D4E9-DB88-BB1B-5B32-F9224E9A2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9E2AC5-99B0-8CB3-CEAA-63E63170F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774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48953-F55D-32B2-992E-8DD578907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F1AA08-1330-3920-4E5E-25BF2BB3E1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FFDCFF-DA23-A5CB-14D8-F2EF2805C3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A12997-E538-1ADA-A185-27C7E3955E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63D729-A87D-B62F-49E1-5ADA776968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65BCDB-769F-1C95-387F-2971666CC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904035-F89D-844D-2477-E4653CFE3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268C9D-8140-2339-2233-59EED7D7F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465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67F48-9DA7-FEE4-9CF4-317540BF49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75E515-FE9B-49AC-02AD-C96784EDC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3888D8-1D9E-5CEC-23B4-1A97D3613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BEB80F-0319-36A1-5CFA-74B525812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041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ADCF60-D21F-CFE7-B2BB-9651D4E4C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29ACC7-80A4-7ABE-700B-8531B9704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F1A7B7-AE24-DAB5-7692-1F5A87B94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412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192E4-CF3C-6BF7-A381-2D62CB4DA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790BCA-763A-99A9-61E5-F8CB01F758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2648C3-049A-3D5D-5030-BB9CCD52C9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AA04B6-8DA6-1F83-689F-7E7F4C27E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01544-3FE0-0383-D72D-A36496DB4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144D8E-3213-B567-1773-0E5FFF69C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168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A7E65-DD44-9D8D-EB09-3E6D792C8B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92D029-BE82-262A-50DB-F2CB4B2557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7B9F2A-3E22-7817-9FC1-F0A41E20B7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BEE074-E311-4525-32F0-A39B13681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7FFE2F-1B02-BB31-2940-5AD420A01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B480A1-9779-7484-A237-B07C87EC2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370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B71A48-9D44-9134-DADE-0E99C3818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007C6-495D-A658-0373-4305D0158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16C3D-38B6-2502-CB1C-1A378D1B12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1BAFD3-8136-4CAA-BDB9-3150654A68D3}" type="datetimeFigureOut">
              <a:rPr lang="en-US" smtClean="0"/>
              <a:t>4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D7498-AA3A-00BB-6C4E-8982D59A71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8E8B7E-573A-5ED8-CDB3-54B4B6441F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73FAAF-CE90-45C1-B06A-626237E2BE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53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plant life cycle&#10;&#10;AI-generated content may be incorrect.">
            <a:extLst>
              <a:ext uri="{FF2B5EF4-FFF2-40B4-BE49-F238E27FC236}">
                <a16:creationId xmlns:a16="http://schemas.microsoft.com/office/drawing/2014/main" id="{A9468E83-595F-B768-DD07-933DE96CAC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94" y="353290"/>
            <a:ext cx="11249898" cy="63280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E8E83B2-20E1-55BA-C1E4-024E7CBB3205}"/>
              </a:ext>
            </a:extLst>
          </p:cNvPr>
          <p:cNvSpPr txBox="1"/>
          <p:nvPr/>
        </p:nvSpPr>
        <p:spPr>
          <a:xfrm>
            <a:off x="99128" y="4215993"/>
            <a:ext cx="1192803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1. Isolation of H9 antibody. </a:t>
            </a:r>
            <a:r>
              <a:rPr lang="en-US" sz="14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Monoclonal antibodies were generated via conventional hybridoma procedures using </a:t>
            </a:r>
            <a:r>
              <a:rPr lang="en-US" sz="140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alb</a:t>
            </a:r>
            <a:r>
              <a:rPr lang="en-US" sz="14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/C mice immunized with the extracellular domain (ECD) of recombinant canine PD-1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cPD-1)</a:t>
            </a:r>
            <a:r>
              <a:rPr lang="en-US" sz="14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Splenocytes were isolated from the immunized mice and then fused with SP2/0 myeloma cells. Cell fusions were performed by electrofusion and plated onto 96 well plates. Supernatants were screened by ELISA with PD-1 ECD protein and by flow cytometry using CHO cells that overexpressed canine PD-1. From this screening, five individual PD-1 monoclonal antibodies were isotyped and prepared as purified IgG for binding and functional studies. Clone 77A6H9 was selected as the lead antibody. </a:t>
            </a:r>
          </a:p>
        </p:txBody>
      </p:sp>
    </p:spTree>
    <p:extLst>
      <p:ext uri="{BB962C8B-B14F-4D97-AF65-F5344CB8AC3E}">
        <p14:creationId xmlns:p14="http://schemas.microsoft.com/office/powerpoint/2010/main" val="15199253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AA9278C2-07F1-CCE7-7A4A-8A8C121DD69F}"/>
              </a:ext>
            </a:extLst>
          </p:cNvPr>
          <p:cNvGrpSpPr/>
          <p:nvPr/>
        </p:nvGrpSpPr>
        <p:grpSpPr>
          <a:xfrm>
            <a:off x="167935" y="826461"/>
            <a:ext cx="1669385" cy="2809214"/>
            <a:chOff x="4183380" y="1548182"/>
            <a:chExt cx="1912620" cy="2903220"/>
          </a:xfrm>
        </p:grpSpPr>
        <p:pic>
          <p:nvPicPr>
            <p:cNvPr id="8" name="Picture 7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FF8B72C3-B8C0-7CDD-F323-FAC537DF02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83380" y="1548182"/>
              <a:ext cx="1912620" cy="290322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1A19C52-C713-BCCC-61F8-E597437DAB64}"/>
                </a:ext>
              </a:extLst>
            </p:cNvPr>
            <p:cNvSpPr txBox="1"/>
            <p:nvPr/>
          </p:nvSpPr>
          <p:spPr>
            <a:xfrm>
              <a:off x="5296433" y="15761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anose="020B0604020202020204" pitchFamily="34" charset="0"/>
                  <a:cs typeface="Helvetica" panose="020B0604020202020204" pitchFamily="34" charset="0"/>
                </a:rPr>
                <a:t>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93D21D8-7AB1-98C8-D0D0-7EF04A3EBBE7}"/>
                </a:ext>
              </a:extLst>
            </p:cNvPr>
            <p:cNvSpPr txBox="1"/>
            <p:nvPr/>
          </p:nvSpPr>
          <p:spPr>
            <a:xfrm>
              <a:off x="5607452" y="1576175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>
                  <a:latin typeface="Helvetica" panose="020B0604020202020204" pitchFamily="34" charset="0"/>
                  <a:cs typeface="Helvetica" panose="020B0604020202020204" pitchFamily="34" charset="0"/>
                </a:rPr>
                <a:t>NR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AA888CC-2E4A-FCFD-87F3-E212676BFD4C}"/>
              </a:ext>
            </a:extLst>
          </p:cNvPr>
          <p:cNvSpPr txBox="1"/>
          <p:nvPr/>
        </p:nvSpPr>
        <p:spPr>
          <a:xfrm>
            <a:off x="84022" y="758329"/>
            <a:ext cx="312906" cy="306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9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EDE3C74-8EEF-4F65-DC8E-066E6C3F9D82}"/>
              </a:ext>
            </a:extLst>
          </p:cNvPr>
          <p:cNvGrpSpPr/>
          <p:nvPr/>
        </p:nvGrpSpPr>
        <p:grpSpPr>
          <a:xfrm>
            <a:off x="1955104" y="758328"/>
            <a:ext cx="5080486" cy="2847210"/>
            <a:chOff x="1826095" y="830456"/>
            <a:chExt cx="5263544" cy="2847210"/>
          </a:xfrm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B20FC8EC-73AE-2233-A37D-83D370178C4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90621" y="1059691"/>
              <a:ext cx="5199018" cy="261797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C1D66BB-B09A-BC38-F577-60DFFD1C6372}"/>
                </a:ext>
              </a:extLst>
            </p:cNvPr>
            <p:cNvSpPr txBox="1"/>
            <p:nvPr/>
          </p:nvSpPr>
          <p:spPr>
            <a:xfrm>
              <a:off x="1826095" y="830456"/>
              <a:ext cx="321761" cy="3063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91" dirty="0">
                  <a:latin typeface="Helvetica" panose="020B0604020202020204" pitchFamily="34" charset="0"/>
                  <a:cs typeface="Helvetica" panose="020B0604020202020204" pitchFamily="34" charset="0"/>
                </a:rPr>
                <a:t>B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3A02E7C6-A808-7D26-19D4-1D1F9EB0A449}"/>
              </a:ext>
            </a:extLst>
          </p:cNvPr>
          <p:cNvSpPr txBox="1"/>
          <p:nvPr/>
        </p:nvSpPr>
        <p:spPr>
          <a:xfrm>
            <a:off x="111745" y="4273083"/>
            <a:ext cx="11973587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2. Characterization of H9 antibody.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SDS-PAGE image showing the presence of H9 at 150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D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A); d</a:t>
            </a:r>
            <a:r>
              <a:rPr lang="en-US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ynamic light scattering indicates the presence of a single peak around 5.4 nm with an estimated molecular weight by radius (Mw-R) of 175.3 </a:t>
            </a:r>
            <a:r>
              <a:rPr lang="en-US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Da</a:t>
            </a:r>
            <a:r>
              <a:rPr lang="en-US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B), and SEC-HPLC shows a single peak with a 99.6% purity (inset on the top left; and the single peak without standards on the top right inset)(C). The y-axis refers to milli absorbance units (</a:t>
            </a:r>
            <a:r>
              <a:rPr lang="en-US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U</a:t>
            </a:r>
            <a:r>
              <a:rPr lang="en-US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of H9 by the detector and the x-axis refers to the retention time for H9. P</a:t>
            </a:r>
            <a:r>
              <a:rPr lang="en-US" sz="14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otein standard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used to </a:t>
            </a:r>
            <a:r>
              <a:rPr lang="en-US" sz="14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stimate molecular weight (MW, in kilo Daltons; </a:t>
            </a:r>
            <a:r>
              <a:rPr lang="en-US" sz="14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Da</a:t>
            </a:r>
            <a:r>
              <a:rPr lang="en-US" sz="14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conformation, and retention time (RT) of H9. R, reducing; NR, non-reducing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87F1A8-169D-0DFC-36E4-24B9CA09C77E}"/>
              </a:ext>
            </a:extLst>
          </p:cNvPr>
          <p:cNvSpPr txBox="1"/>
          <p:nvPr/>
        </p:nvSpPr>
        <p:spPr>
          <a:xfrm>
            <a:off x="6920557" y="734326"/>
            <a:ext cx="312906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B61E062-48D4-56AB-5E6E-0F5AD837E936}"/>
              </a:ext>
            </a:extLst>
          </p:cNvPr>
          <p:cNvGrpSpPr/>
          <p:nvPr/>
        </p:nvGrpSpPr>
        <p:grpSpPr>
          <a:xfrm>
            <a:off x="6920557" y="734326"/>
            <a:ext cx="5102925" cy="3245810"/>
            <a:chOff x="6920557" y="734326"/>
            <a:chExt cx="5102925" cy="3245810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5328D3E-3F7C-8C93-65BA-C532C28B70F6}"/>
                </a:ext>
              </a:extLst>
            </p:cNvPr>
            <p:cNvSpPr txBox="1"/>
            <p:nvPr/>
          </p:nvSpPr>
          <p:spPr>
            <a:xfrm>
              <a:off x="6920557" y="734326"/>
              <a:ext cx="312906" cy="30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91" dirty="0"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6FBD48F-4758-94D6-29AA-BD569CB77C12}"/>
                </a:ext>
              </a:extLst>
            </p:cNvPr>
            <p:cNvGrpSpPr/>
            <p:nvPr/>
          </p:nvGrpSpPr>
          <p:grpSpPr>
            <a:xfrm>
              <a:off x="7215670" y="826461"/>
              <a:ext cx="4807812" cy="3153675"/>
              <a:chOff x="7050604" y="757998"/>
              <a:chExt cx="5032132" cy="3300817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82D9BB1F-4C11-80D1-169D-9CEDAC61A9D3}"/>
                  </a:ext>
                </a:extLst>
              </p:cNvPr>
              <p:cNvGrpSpPr/>
              <p:nvPr/>
            </p:nvGrpSpPr>
            <p:grpSpPr>
              <a:xfrm>
                <a:off x="7050604" y="757998"/>
                <a:ext cx="5032132" cy="3300817"/>
                <a:chOff x="8752109" y="797287"/>
                <a:chExt cx="4413382" cy="2407780"/>
              </a:xfrm>
            </p:grpSpPr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B814BD12-C637-3569-7AEE-78B39127F4C9}"/>
                    </a:ext>
                  </a:extLst>
                </p:cNvPr>
                <p:cNvGrpSpPr/>
                <p:nvPr/>
              </p:nvGrpSpPr>
              <p:grpSpPr>
                <a:xfrm>
                  <a:off x="8752109" y="797287"/>
                  <a:ext cx="4413382" cy="2407780"/>
                  <a:chOff x="4674633" y="797287"/>
                  <a:chExt cx="4413382" cy="2407780"/>
                </a:xfrm>
              </p:grpSpPr>
              <p:pic>
                <p:nvPicPr>
                  <p:cNvPr id="24" name="Picture 23" descr="A graph of a normalized curve&#10;&#10;Description automatically generated with medium confidence">
                    <a:extLst>
                      <a:ext uri="{FF2B5EF4-FFF2-40B4-BE49-F238E27FC236}">
                        <a16:creationId xmlns:a16="http://schemas.microsoft.com/office/drawing/2014/main" id="{250BE3CF-F197-63AC-1BF7-9717CBF2E70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674633" y="797287"/>
                    <a:ext cx="4413382" cy="2407780"/>
                  </a:xfrm>
                  <a:prstGeom prst="rect">
                    <a:avLst/>
                  </a:prstGeom>
                </p:spPr>
              </p:pic>
              <p:pic>
                <p:nvPicPr>
                  <p:cNvPr id="25" name="Picture 24">
                    <a:extLst>
                      <a:ext uri="{FF2B5EF4-FFF2-40B4-BE49-F238E27FC236}">
                        <a16:creationId xmlns:a16="http://schemas.microsoft.com/office/drawing/2014/main" id="{D5B1C101-6D48-E525-F935-8547ED67410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4917233" y="825928"/>
                    <a:ext cx="1296957" cy="516674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3" name="Picture 22" descr="A graph of a normalized curve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A0C40560-95A6-EDC7-D129-B8BB2D98B94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600951" y="832195"/>
                  <a:ext cx="1536555" cy="834669"/>
                </a:xfrm>
                <a:prstGeom prst="rect">
                  <a:avLst/>
                </a:prstGeom>
              </p:spPr>
            </p:pic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AC83B74-7EA2-4BB6-EE17-31E74B39D3CC}"/>
                  </a:ext>
                </a:extLst>
              </p:cNvPr>
              <p:cNvSpPr txBox="1"/>
              <p:nvPr/>
            </p:nvSpPr>
            <p:spPr>
              <a:xfrm>
                <a:off x="7362176" y="1575899"/>
                <a:ext cx="914025" cy="50783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Buffer</a:t>
                </a:r>
                <a:r>
                  <a:rPr lang="en-US" sz="900" dirty="0">
                    <a:solidFill>
                      <a:srgbClr val="0085D5"/>
                    </a:solidFill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sz="900" dirty="0">
                    <a:solidFill>
                      <a:schemeClr val="accent2">
                        <a:lumMod val="75000"/>
                      </a:schemeClr>
                    </a:solidFill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Standard</a:t>
                </a:r>
                <a:r>
                  <a:rPr lang="en-US" sz="900" dirty="0">
                    <a:solidFill>
                      <a:srgbClr val="0085D5"/>
                    </a:solidFill>
                    <a:effectLst/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     H9</a:t>
                </a:r>
                <a:endParaRPr lang="en-US" sz="900" dirty="0">
                  <a:solidFill>
                    <a:srgbClr val="0085D5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832490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A78DD5-4691-90E0-CCCD-54ED7CF3E0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37EA38CF-FE45-77A4-22B3-FDB8C4C776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8" y="0"/>
            <a:ext cx="12189023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346C8FA-7B2C-BBB7-55F3-89EAE87B72C8}"/>
              </a:ext>
            </a:extLst>
          </p:cNvPr>
          <p:cNvSpPr txBox="1"/>
          <p:nvPr/>
        </p:nvSpPr>
        <p:spPr>
          <a:xfrm>
            <a:off x="2515344" y="4618334"/>
            <a:ext cx="6949769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3. Alignment of human and canine hing</a:t>
            </a:r>
            <a:r>
              <a:rPr lang="en-US" sz="14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 region of </a:t>
            </a:r>
            <a:r>
              <a:rPr lang="en-US" sz="14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gG antibodies.</a:t>
            </a:r>
            <a:r>
              <a:rPr lang="en-US" sz="14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ysteines highlighted in red boxes indicate residues that form interchain disulfide bonds in human IgG4 and potentially in canine IgG4, contributing to Fab-arm exchange instability.</a:t>
            </a:r>
          </a:p>
        </p:txBody>
      </p:sp>
    </p:spTree>
    <p:extLst>
      <p:ext uri="{BB962C8B-B14F-4D97-AF65-F5344CB8AC3E}">
        <p14:creationId xmlns:p14="http://schemas.microsoft.com/office/powerpoint/2010/main" val="14961443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E461B48-A03B-1BF6-E79D-4EC423633DF6}"/>
              </a:ext>
            </a:extLst>
          </p:cNvPr>
          <p:cNvSpPr txBox="1"/>
          <p:nvPr/>
        </p:nvSpPr>
        <p:spPr>
          <a:xfrm>
            <a:off x="353291" y="3891598"/>
            <a:ext cx="11542533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4. Characterization of caninized antibody HugPetmab.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resentative SDS-PAGE gel of HugPetmab. LC-MS revealed Bands 1 (~180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a) and 3 (~75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contain both the heavy and light chains at an approximate ratio of 1:1. Band 2 (~120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a)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ins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he heavy chain; Band 4 (~50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a)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ains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he light chain. DLS imaging indicates the presence of a single peak around 5.8 nm with an estimated MW of 206.8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B), and SEC-HPLC chromogram shows a single peak with molecular weight of 182.7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ith 94.6% purity (inset on the top left; and the single peak without standards is on the top right inset)(C). Protein standards were used to estimate </a:t>
            </a:r>
            <a:r>
              <a:rPr kumimoji="0" lang="en-US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lecular weight (MW), conformation, and retention time (RT) of HugPetmab. R, reducing, NR, non-reducing;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w-R, molecular weight by radius;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U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efers to milli absorbance units or absorption of </a:t>
            </a:r>
            <a:r>
              <a:rPr kumimoji="0" lang="en-US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gPetmab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y the detector; and the X-axis (time, min) refers to the retention time for </a:t>
            </a:r>
            <a:r>
              <a:rPr kumimoji="0" lang="en-US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gPetmab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C5EDD79F-AB27-D649-B9A4-4EF9AD6A1603}"/>
              </a:ext>
            </a:extLst>
          </p:cNvPr>
          <p:cNvGrpSpPr/>
          <p:nvPr/>
        </p:nvGrpSpPr>
        <p:grpSpPr>
          <a:xfrm>
            <a:off x="7423213" y="1087905"/>
            <a:ext cx="4478568" cy="2454650"/>
            <a:chOff x="7366062" y="1077684"/>
            <a:chExt cx="4478568" cy="2454650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848F1DFE-2586-F473-2E44-E6FBE6447880}"/>
                </a:ext>
              </a:extLst>
            </p:cNvPr>
            <p:cNvGrpSpPr/>
            <p:nvPr/>
          </p:nvGrpSpPr>
          <p:grpSpPr>
            <a:xfrm>
              <a:off x="7366062" y="1077684"/>
              <a:ext cx="4478568" cy="2454650"/>
              <a:chOff x="2663190" y="1353310"/>
              <a:chExt cx="6874764" cy="4136900"/>
            </a:xfrm>
          </p:grpSpPr>
          <p:pic>
            <p:nvPicPr>
              <p:cNvPr id="13" name="Picture 12" descr="A graph of a normalized time&#10;&#10;Description automatically generated with medium confidence">
                <a:extLst>
                  <a:ext uri="{FF2B5EF4-FFF2-40B4-BE49-F238E27FC236}">
                    <a16:creationId xmlns:a16="http://schemas.microsoft.com/office/drawing/2014/main" id="{6440DE3F-1C01-56EE-AAF4-67260488BF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63190" y="1367790"/>
                <a:ext cx="6865620" cy="4122420"/>
              </a:xfrm>
              <a:prstGeom prst="rect">
                <a:avLst/>
              </a:prstGeom>
            </p:spPr>
          </p:pic>
          <p:pic>
            <p:nvPicPr>
              <p:cNvPr id="14" name="Picture 13" descr="A graph of a normalized time&#10;&#10;Description automatically generated with medium confidence">
                <a:extLst>
                  <a:ext uri="{FF2B5EF4-FFF2-40B4-BE49-F238E27FC236}">
                    <a16:creationId xmlns:a16="http://schemas.microsoft.com/office/drawing/2014/main" id="{C3B33DF0-B839-8B80-D798-6F0A1967F1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59838" y="1393807"/>
                <a:ext cx="2378116" cy="1457372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D66EF73A-0CEE-94B5-2507-3F572DAF41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176901" y="1353310"/>
                <a:ext cx="2358123" cy="1014984"/>
              </a:xfrm>
              <a:prstGeom prst="rect">
                <a:avLst/>
              </a:prstGeom>
            </p:spPr>
          </p:pic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30A1DE5-030A-3544-8776-FC3FD47D154C}"/>
                </a:ext>
              </a:extLst>
            </p:cNvPr>
            <p:cNvSpPr txBox="1"/>
            <p:nvPr/>
          </p:nvSpPr>
          <p:spPr>
            <a:xfrm>
              <a:off x="7700719" y="1704361"/>
              <a:ext cx="914025" cy="50783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Buffer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0085D5"/>
                  </a:solidFill>
                  <a:effectLst/>
                  <a:uLnTx/>
                  <a:uFillTx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    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E97132">
                      <a:lumMod val="75000"/>
                    </a:srgbClr>
                  </a:solidFill>
                  <a:effectLst/>
                  <a:uLnTx/>
                  <a:uFillTx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Standard</a:t>
              </a: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srgbClr val="0085D5"/>
                  </a:solidFill>
                  <a:effectLst/>
                  <a:uLnTx/>
                  <a:uFillTx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     </a:t>
              </a:r>
              <a:r>
                <a:rPr kumimoji="0" lang="en-US" sz="900" b="0" i="0" u="none" strike="noStrike" kern="1200" cap="none" spc="0" normalizeH="0" baseline="0" noProof="0" dirty="0" err="1">
                  <a:ln>
                    <a:noFill/>
                  </a:ln>
                  <a:solidFill>
                    <a:srgbClr val="0085D5"/>
                  </a:solidFill>
                  <a:effectLst/>
                  <a:uLnTx/>
                  <a:uFillTx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HugPetMab</a:t>
              </a:r>
              <a:endPara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0085D5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2E481CA-4E9C-FE0B-108E-51E6CE124F7F}"/>
              </a:ext>
            </a:extLst>
          </p:cNvPr>
          <p:cNvSpPr txBox="1"/>
          <p:nvPr/>
        </p:nvSpPr>
        <p:spPr>
          <a:xfrm>
            <a:off x="7200070" y="98675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C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7B48912F-5132-C86F-4BAA-4E92FFF2618A}"/>
              </a:ext>
            </a:extLst>
          </p:cNvPr>
          <p:cNvGrpSpPr/>
          <p:nvPr/>
        </p:nvGrpSpPr>
        <p:grpSpPr>
          <a:xfrm>
            <a:off x="231194" y="969436"/>
            <a:ext cx="6980616" cy="2712760"/>
            <a:chOff x="231194" y="969436"/>
            <a:chExt cx="6980616" cy="2712760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E401A14-70F6-12BC-EA38-25680B3CC364}"/>
                </a:ext>
              </a:extLst>
            </p:cNvPr>
            <p:cNvGrpSpPr/>
            <p:nvPr/>
          </p:nvGrpSpPr>
          <p:grpSpPr>
            <a:xfrm>
              <a:off x="231194" y="969436"/>
              <a:ext cx="6980616" cy="2712760"/>
              <a:chOff x="231194" y="969436"/>
              <a:chExt cx="6980616" cy="2712760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E850F46-B153-D36E-7600-1A33DA79685A}"/>
                  </a:ext>
                </a:extLst>
              </p:cNvPr>
              <p:cNvSpPr txBox="1"/>
              <p:nvPr/>
            </p:nvSpPr>
            <p:spPr>
              <a:xfrm>
                <a:off x="231194" y="973908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A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06DB3DF-1179-EB81-A4A5-CC43389AA16A}"/>
                  </a:ext>
                </a:extLst>
              </p:cNvPr>
              <p:cNvSpPr txBox="1"/>
              <p:nvPr/>
            </p:nvSpPr>
            <p:spPr>
              <a:xfrm>
                <a:off x="2330202" y="969436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B</a:t>
                </a:r>
              </a:p>
            </p:txBody>
          </p:sp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2856A38D-C1D5-798E-6A32-9A5A3732A0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561152" y="1057519"/>
                <a:ext cx="4650658" cy="2624677"/>
              </a:xfrm>
              <a:prstGeom prst="rect">
                <a:avLst/>
              </a:prstGeom>
            </p:spPr>
          </p:pic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361FF257-56AC-219E-4BCB-BBD0AD0AB10F}"/>
                  </a:ext>
                </a:extLst>
              </p:cNvPr>
              <p:cNvGrpSpPr/>
              <p:nvPr/>
            </p:nvGrpSpPr>
            <p:grpSpPr>
              <a:xfrm>
                <a:off x="506563" y="1057519"/>
                <a:ext cx="1418535" cy="2484145"/>
                <a:chOff x="4416413" y="1886373"/>
                <a:chExt cx="1763831" cy="2886374"/>
              </a:xfrm>
            </p:grpSpPr>
            <p:pic>
              <p:nvPicPr>
                <p:cNvPr id="16" name="Picture 15" descr="A close-up of a dna test&#10;&#10;AI-generated content may be incorrect.">
                  <a:extLst>
                    <a:ext uri="{FF2B5EF4-FFF2-40B4-BE49-F238E27FC236}">
                      <a16:creationId xmlns:a16="http://schemas.microsoft.com/office/drawing/2014/main" id="{12EC5077-15B0-9D11-D38E-B696FE2804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6413" y="1886373"/>
                  <a:ext cx="1763831" cy="2886374"/>
                </a:xfrm>
                <a:prstGeom prst="rect">
                  <a:avLst/>
                </a:prstGeom>
              </p:spPr>
            </p:pic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C8DA0C10-DBF3-4104-6A36-D43A3649E8F2}"/>
                    </a:ext>
                  </a:extLst>
                </p:cNvPr>
                <p:cNvGrpSpPr/>
                <p:nvPr/>
              </p:nvGrpSpPr>
              <p:grpSpPr>
                <a:xfrm>
                  <a:off x="5296887" y="1895704"/>
                  <a:ext cx="754222" cy="276999"/>
                  <a:chOff x="5296887" y="1895704"/>
                  <a:chExt cx="754222" cy="276999"/>
                </a:xfrm>
              </p:grpSpPr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3269606C-439A-0F7C-563E-80ABDF31717F}"/>
                      </a:ext>
                    </a:extLst>
                  </p:cNvPr>
                  <p:cNvSpPr txBox="1"/>
                  <p:nvPr/>
                </p:nvSpPr>
                <p:spPr>
                  <a:xfrm>
                    <a:off x="5296887" y="1895704"/>
                    <a:ext cx="2952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Helvetica" panose="020B0604020202020204" pitchFamily="34" charset="0"/>
                        <a:ea typeface="+mn-ea"/>
                        <a:cs typeface="Helvetica" panose="020B0604020202020204" pitchFamily="34" charset="0"/>
                      </a:rPr>
                      <a:t>R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529B28A0-0AAD-B6DC-F15C-4E5462C625A3}"/>
                      </a:ext>
                    </a:extLst>
                  </p:cNvPr>
                  <p:cNvSpPr txBox="1"/>
                  <p:nvPr/>
                </p:nvSpPr>
                <p:spPr>
                  <a:xfrm>
                    <a:off x="5645229" y="1895704"/>
                    <a:ext cx="40588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Helvetica" panose="020B0604020202020204" pitchFamily="34" charset="0"/>
                        <a:ea typeface="+mn-ea"/>
                        <a:cs typeface="Helvetica" panose="020B0604020202020204" pitchFamily="34" charset="0"/>
                      </a:rPr>
                      <a:t>NR</a:t>
                    </a:r>
                  </a:p>
                </p:txBody>
              </p:sp>
            </p:grpSp>
          </p:grp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F198F85-E228-5F76-64A2-0CEC5CBD5964}"/>
                </a:ext>
              </a:extLst>
            </p:cNvPr>
            <p:cNvSpPr txBox="1"/>
            <p:nvPr/>
          </p:nvSpPr>
          <p:spPr>
            <a:xfrm>
              <a:off x="1756907" y="1062115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+mn-ea"/>
                  <a:cs typeface="Helvetica" panose="020B0604020202020204" pitchFamily="34" charset="0"/>
                </a:rPr>
                <a:t>Band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FFDC43A3-764B-6EA9-9E9E-5E0DD6797B97}"/>
                </a:ext>
              </a:extLst>
            </p:cNvPr>
            <p:cNvGrpSpPr/>
            <p:nvPr/>
          </p:nvGrpSpPr>
          <p:grpSpPr>
            <a:xfrm>
              <a:off x="1906787" y="1443113"/>
              <a:ext cx="269626" cy="1198340"/>
              <a:chOff x="1843496" y="1443113"/>
              <a:chExt cx="269626" cy="1198340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12102ED-054C-D574-36CF-62211F1C9271}"/>
                  </a:ext>
                </a:extLst>
              </p:cNvPr>
              <p:cNvSpPr txBox="1"/>
              <p:nvPr/>
            </p:nvSpPr>
            <p:spPr>
              <a:xfrm>
                <a:off x="1843496" y="1443113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219CEA5-A0E3-D917-89B6-EECEBBCD4C56}"/>
                  </a:ext>
                </a:extLst>
              </p:cNvPr>
              <p:cNvSpPr txBox="1"/>
              <p:nvPr/>
            </p:nvSpPr>
            <p:spPr>
              <a:xfrm>
                <a:off x="1843496" y="1689036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1D8C4E3-469B-1AEB-852A-407482744519}"/>
                  </a:ext>
                </a:extLst>
              </p:cNvPr>
              <p:cNvSpPr txBox="1"/>
              <p:nvPr/>
            </p:nvSpPr>
            <p:spPr>
              <a:xfrm>
                <a:off x="1843496" y="1941882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3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58B550E-D950-B4FD-21D0-BBAB3A3FA293}"/>
                  </a:ext>
                </a:extLst>
              </p:cNvPr>
              <p:cNvSpPr txBox="1"/>
              <p:nvPr/>
            </p:nvSpPr>
            <p:spPr>
              <a:xfrm>
                <a:off x="1843496" y="2364454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+mn-ea"/>
                    <a:cs typeface="Helvetica" panose="020B0604020202020204" pitchFamily="34" charset="0"/>
                  </a:rPr>
                  <a:t>4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54063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518</Words>
  <Application>Microsoft Office PowerPoint</Application>
  <PresentationFormat>Widescreen</PresentationFormat>
  <Paragraphs>2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go Ariaspulido</dc:creator>
  <cp:lastModifiedBy>Colin Hartman</cp:lastModifiedBy>
  <cp:revision>7</cp:revision>
  <dcterms:created xsi:type="dcterms:W3CDTF">2025-10-17T14:07:20Z</dcterms:created>
  <dcterms:modified xsi:type="dcterms:W3CDTF">2026-04-11T20:00:35Z</dcterms:modified>
</cp:coreProperties>
</file>